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96EF6F-184A-4A97-9EF8-13BF22B577E6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8D0285C-79EF-40EA-BD43-B618CCAA1E7F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1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mmon trends identified from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. multocid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response to sub-MIC antibiotics. AMX, amoxicillin; CTC, chlortetracycline; and ENR, enrofloxacin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D49AF7-CABE-4BA5-BCAD-64A1229013F5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1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mmon trends identified from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. multocid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response to sub-MIC antibiotics. AMX, amoxicillin; CTC, chlortetracycline; and ENR, enrofloxaci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1C65F6B-5CF6-48DA-AB61-341FB144D118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2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mmon trends identified from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. multocid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response to sub-MIC antibiotics. AMX, amoxicillin; CTC, chlortetracycline; and ENR, enrofloxaci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94338E-C22D-406B-BD9B-4340E767330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21E1D2-679C-4FEA-94B0-398B3DC19F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32E963-0C3B-4EF3-B73C-EB93B7DAF88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04B940-3DD2-42E1-97F8-7807536D54B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CE0D09-3E40-43DE-94A3-ABE3840D43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558B22-F914-4916-8D30-3CE41CAE30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8ACCEF-21EE-4D3B-8EC3-85AB1EB35D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A85FF0-7260-4972-9163-538C664A3B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EC9C82-5E14-4863-9FDF-27191AA5C6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8C7495-C059-4A7E-AB38-8254C1F452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43BC5E-AA90-46E2-A5E3-C2F2897407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50FF63-7D8B-4B22-9047-A6F81CDCD6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8AAF2E-D8AB-4350-A1C9-99E4E87569B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5" descr=""/>
          <p:cNvPicPr/>
          <p:nvPr/>
        </p:nvPicPr>
        <p:blipFill>
          <a:blip r:embed="rId1"/>
          <a:stretch/>
        </p:blipFill>
        <p:spPr>
          <a:xfrm>
            <a:off x="7920" y="220680"/>
            <a:ext cx="9128160" cy="6416640"/>
          </a:xfrm>
          <a:prstGeom prst="rect">
            <a:avLst/>
          </a:prstGeom>
          <a:ln w="0">
            <a:noFill/>
          </a:ln>
        </p:spPr>
      </p:pic>
      <p:grpSp>
        <p:nvGrpSpPr>
          <p:cNvPr id="49" name="Group 28"/>
          <p:cNvGrpSpPr/>
          <p:nvPr/>
        </p:nvGrpSpPr>
        <p:grpSpPr>
          <a:xfrm>
            <a:off x="593640" y="360360"/>
            <a:ext cx="8212320" cy="5575680"/>
            <a:chOff x="593640" y="360360"/>
            <a:chExt cx="8212320" cy="5575680"/>
          </a:xfrm>
        </p:grpSpPr>
        <p:sp>
          <p:nvSpPr>
            <p:cNvPr id="50" name="Rectangle 6"/>
            <p:cNvSpPr/>
            <p:nvPr/>
          </p:nvSpPr>
          <p:spPr>
            <a:xfrm>
              <a:off x="3299040" y="396720"/>
              <a:ext cx="83304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Glycoly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7"/>
            <p:cNvSpPr/>
            <p:nvPr/>
          </p:nvSpPr>
          <p:spPr>
            <a:xfrm flipH="1" flipV="1">
              <a:off x="4170240" y="649440"/>
              <a:ext cx="2084400" cy="113328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8"/>
            <p:cNvSpPr/>
            <p:nvPr/>
          </p:nvSpPr>
          <p:spPr>
            <a:xfrm flipV="1">
              <a:off x="1390680" y="649440"/>
              <a:ext cx="2303280" cy="219384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9"/>
            <p:cNvSpPr/>
            <p:nvPr/>
          </p:nvSpPr>
          <p:spPr>
            <a:xfrm flipH="1" flipV="1">
              <a:off x="4059000" y="649440"/>
              <a:ext cx="731880" cy="91440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10"/>
            <p:cNvSpPr/>
            <p:nvPr/>
          </p:nvSpPr>
          <p:spPr>
            <a:xfrm flipH="1" flipV="1">
              <a:off x="3839760" y="649080"/>
              <a:ext cx="2305080" cy="358452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11"/>
            <p:cNvSpPr/>
            <p:nvPr/>
          </p:nvSpPr>
          <p:spPr>
            <a:xfrm>
              <a:off x="2230560" y="539640"/>
              <a:ext cx="1062000" cy="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12"/>
            <p:cNvSpPr/>
            <p:nvPr/>
          </p:nvSpPr>
          <p:spPr>
            <a:xfrm>
              <a:off x="593640" y="3720960"/>
              <a:ext cx="892440" cy="45900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Purine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metabolis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13"/>
            <p:cNvSpPr/>
            <p:nvPr/>
          </p:nvSpPr>
          <p:spPr>
            <a:xfrm flipH="1">
              <a:off x="1463760" y="3282840"/>
              <a:ext cx="2303280" cy="58428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14"/>
            <p:cNvSpPr/>
            <p:nvPr/>
          </p:nvSpPr>
          <p:spPr>
            <a:xfrm flipH="1">
              <a:off x="1463760" y="3720960"/>
              <a:ext cx="2303280" cy="22068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15"/>
            <p:cNvSpPr/>
            <p:nvPr/>
          </p:nvSpPr>
          <p:spPr>
            <a:xfrm>
              <a:off x="6006960" y="360360"/>
              <a:ext cx="892440" cy="45900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RNA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metabolis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16"/>
            <p:cNvSpPr/>
            <p:nvPr/>
          </p:nvSpPr>
          <p:spPr>
            <a:xfrm flipV="1">
              <a:off x="5413320" y="831600"/>
              <a:ext cx="695520" cy="124452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17"/>
            <p:cNvSpPr/>
            <p:nvPr/>
          </p:nvSpPr>
          <p:spPr>
            <a:xfrm flipV="1">
              <a:off x="4827600" y="831960"/>
              <a:ext cx="1171440" cy="128088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18"/>
            <p:cNvSpPr/>
            <p:nvPr/>
          </p:nvSpPr>
          <p:spPr>
            <a:xfrm flipV="1">
              <a:off x="4389480" y="649080"/>
              <a:ext cx="1609560" cy="131580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19"/>
            <p:cNvSpPr/>
            <p:nvPr/>
          </p:nvSpPr>
          <p:spPr>
            <a:xfrm flipV="1">
              <a:off x="658800" y="539280"/>
              <a:ext cx="5340240" cy="127980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20"/>
            <p:cNvSpPr/>
            <p:nvPr/>
          </p:nvSpPr>
          <p:spPr>
            <a:xfrm>
              <a:off x="5383440" y="5659560"/>
              <a:ext cx="129780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Response to stres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21"/>
            <p:cNvSpPr/>
            <p:nvPr/>
          </p:nvSpPr>
          <p:spPr>
            <a:xfrm>
              <a:off x="4754520" y="4929120"/>
              <a:ext cx="804960" cy="69372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22"/>
            <p:cNvSpPr/>
            <p:nvPr/>
          </p:nvSpPr>
          <p:spPr>
            <a:xfrm>
              <a:off x="3803760" y="4856040"/>
              <a:ext cx="1646280" cy="83988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23"/>
            <p:cNvSpPr/>
            <p:nvPr/>
          </p:nvSpPr>
          <p:spPr>
            <a:xfrm>
              <a:off x="4352760" y="3794040"/>
              <a:ext cx="1352880" cy="182880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24"/>
            <p:cNvSpPr/>
            <p:nvPr/>
          </p:nvSpPr>
          <p:spPr>
            <a:xfrm>
              <a:off x="2852640" y="2770200"/>
              <a:ext cx="2779920" cy="285264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25"/>
            <p:cNvSpPr/>
            <p:nvPr/>
          </p:nvSpPr>
          <p:spPr>
            <a:xfrm>
              <a:off x="7870680" y="4270320"/>
              <a:ext cx="935280" cy="45900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cell wall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biosynthe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26"/>
            <p:cNvSpPr/>
            <p:nvPr/>
          </p:nvSpPr>
          <p:spPr>
            <a:xfrm>
              <a:off x="5340240" y="3173400"/>
              <a:ext cx="2487600" cy="113364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27"/>
            <p:cNvSpPr/>
            <p:nvPr/>
          </p:nvSpPr>
          <p:spPr>
            <a:xfrm>
              <a:off x="4863960" y="3246480"/>
              <a:ext cx="2963880" cy="117000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2" name="Text Box 29"/>
          <p:cNvSpPr/>
          <p:nvPr/>
        </p:nvSpPr>
        <p:spPr>
          <a:xfrm>
            <a:off x="165960" y="236520"/>
            <a:ext cx="71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MX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3" name="Picture 2" descr=""/>
          <p:cNvPicPr/>
          <p:nvPr/>
        </p:nvPicPr>
        <p:blipFill>
          <a:blip r:embed="rId1"/>
          <a:stretch/>
        </p:blipFill>
        <p:spPr>
          <a:xfrm>
            <a:off x="203040" y="503280"/>
            <a:ext cx="8831520" cy="5813280"/>
          </a:xfrm>
          <a:prstGeom prst="rect">
            <a:avLst/>
          </a:prstGeom>
          <a:ln w="0">
            <a:noFill/>
          </a:ln>
        </p:spPr>
      </p:pic>
      <p:grpSp>
        <p:nvGrpSpPr>
          <p:cNvPr id="74" name="Group 19"/>
          <p:cNvGrpSpPr/>
          <p:nvPr/>
        </p:nvGrpSpPr>
        <p:grpSpPr>
          <a:xfrm>
            <a:off x="622440" y="284040"/>
            <a:ext cx="8022960" cy="5177160"/>
            <a:chOff x="622440" y="284040"/>
            <a:chExt cx="8022960" cy="5177160"/>
          </a:xfrm>
        </p:grpSpPr>
        <p:sp>
          <p:nvSpPr>
            <p:cNvPr id="75" name="Rectangle 3"/>
            <p:cNvSpPr/>
            <p:nvPr/>
          </p:nvSpPr>
          <p:spPr>
            <a:xfrm>
              <a:off x="3481560" y="542880"/>
              <a:ext cx="83304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Glycoly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4"/>
            <p:cNvSpPr/>
            <p:nvPr/>
          </p:nvSpPr>
          <p:spPr>
            <a:xfrm flipV="1">
              <a:off x="3402000" y="831600"/>
              <a:ext cx="328680" cy="190188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5"/>
            <p:cNvSpPr/>
            <p:nvPr/>
          </p:nvSpPr>
          <p:spPr>
            <a:xfrm flipV="1">
              <a:off x="3693960" y="794880"/>
              <a:ext cx="109800" cy="215748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6"/>
            <p:cNvSpPr/>
            <p:nvPr/>
          </p:nvSpPr>
          <p:spPr>
            <a:xfrm flipH="1" flipV="1">
              <a:off x="4022640" y="831600"/>
              <a:ext cx="403200" cy="212076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7"/>
            <p:cNvSpPr/>
            <p:nvPr/>
          </p:nvSpPr>
          <p:spPr>
            <a:xfrm flipH="1" flipV="1">
              <a:off x="4280040" y="831600"/>
              <a:ext cx="1682640" cy="139068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8"/>
            <p:cNvSpPr/>
            <p:nvPr/>
          </p:nvSpPr>
          <p:spPr>
            <a:xfrm>
              <a:off x="5121360" y="284040"/>
              <a:ext cx="987480" cy="45900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RNA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metabolis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9"/>
            <p:cNvSpPr/>
            <p:nvPr/>
          </p:nvSpPr>
          <p:spPr>
            <a:xfrm flipV="1">
              <a:off x="4718160" y="721800"/>
              <a:ext cx="622080" cy="153684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10"/>
            <p:cNvSpPr/>
            <p:nvPr/>
          </p:nvSpPr>
          <p:spPr>
            <a:xfrm flipV="1">
              <a:off x="622440" y="649440"/>
              <a:ext cx="4498920" cy="153648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11"/>
            <p:cNvSpPr/>
            <p:nvPr/>
          </p:nvSpPr>
          <p:spPr>
            <a:xfrm>
              <a:off x="878040" y="4307040"/>
              <a:ext cx="950760" cy="45900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Purine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metabolis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12"/>
            <p:cNvSpPr/>
            <p:nvPr/>
          </p:nvSpPr>
          <p:spPr>
            <a:xfrm flipH="1">
              <a:off x="1828440" y="2952720"/>
              <a:ext cx="3181320" cy="139068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13"/>
            <p:cNvSpPr/>
            <p:nvPr/>
          </p:nvSpPr>
          <p:spPr>
            <a:xfrm flipH="1">
              <a:off x="1864800" y="3684600"/>
              <a:ext cx="2048040" cy="76824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14"/>
            <p:cNvSpPr/>
            <p:nvPr/>
          </p:nvSpPr>
          <p:spPr>
            <a:xfrm flipH="1">
              <a:off x="1719000" y="3173400"/>
              <a:ext cx="2266920" cy="113364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15"/>
            <p:cNvSpPr/>
            <p:nvPr/>
          </p:nvSpPr>
          <p:spPr>
            <a:xfrm>
              <a:off x="6261480" y="5184720"/>
              <a:ext cx="129780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Response to stres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16"/>
            <p:cNvSpPr/>
            <p:nvPr/>
          </p:nvSpPr>
          <p:spPr>
            <a:xfrm>
              <a:off x="5522760" y="4489560"/>
              <a:ext cx="841680" cy="69516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17"/>
            <p:cNvSpPr/>
            <p:nvPr/>
          </p:nvSpPr>
          <p:spPr>
            <a:xfrm>
              <a:off x="7643880" y="4452840"/>
              <a:ext cx="1001520" cy="45900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cell wall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biosynthe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18"/>
            <p:cNvSpPr/>
            <p:nvPr/>
          </p:nvSpPr>
          <p:spPr>
            <a:xfrm>
              <a:off x="5742000" y="3137040"/>
              <a:ext cx="1901880" cy="131580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1" name="Text Box 20"/>
          <p:cNvSpPr/>
          <p:nvPr/>
        </p:nvSpPr>
        <p:spPr>
          <a:xfrm>
            <a:off x="164880" y="236520"/>
            <a:ext cx="62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T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Picture 4" descr=""/>
          <p:cNvPicPr/>
          <p:nvPr/>
        </p:nvPicPr>
        <p:blipFill>
          <a:blip r:embed="rId1"/>
          <a:stretch/>
        </p:blipFill>
        <p:spPr>
          <a:xfrm>
            <a:off x="219240" y="244440"/>
            <a:ext cx="8978760" cy="6370560"/>
          </a:xfrm>
          <a:prstGeom prst="rect">
            <a:avLst/>
          </a:prstGeom>
          <a:ln w="0">
            <a:noFill/>
          </a:ln>
        </p:spPr>
      </p:pic>
      <p:grpSp>
        <p:nvGrpSpPr>
          <p:cNvPr id="93" name="Group 23"/>
          <p:cNvGrpSpPr/>
          <p:nvPr/>
        </p:nvGrpSpPr>
        <p:grpSpPr>
          <a:xfrm>
            <a:off x="520560" y="320760"/>
            <a:ext cx="7979040" cy="5726160"/>
            <a:chOff x="520560" y="320760"/>
            <a:chExt cx="7979040" cy="5726160"/>
          </a:xfrm>
        </p:grpSpPr>
        <p:sp>
          <p:nvSpPr>
            <p:cNvPr id="94" name="Rectangle 5"/>
            <p:cNvSpPr/>
            <p:nvPr/>
          </p:nvSpPr>
          <p:spPr>
            <a:xfrm>
              <a:off x="3187800" y="360360"/>
              <a:ext cx="83304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Glycoly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6"/>
            <p:cNvSpPr/>
            <p:nvPr/>
          </p:nvSpPr>
          <p:spPr>
            <a:xfrm flipH="1" flipV="1">
              <a:off x="3730680" y="612720"/>
              <a:ext cx="2084400" cy="208440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7"/>
            <p:cNvSpPr/>
            <p:nvPr/>
          </p:nvSpPr>
          <p:spPr>
            <a:xfrm flipH="1" flipV="1">
              <a:off x="3657240" y="649080"/>
              <a:ext cx="476280" cy="197460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8"/>
            <p:cNvSpPr/>
            <p:nvPr/>
          </p:nvSpPr>
          <p:spPr>
            <a:xfrm flipV="1">
              <a:off x="3548160" y="649080"/>
              <a:ext cx="36360" cy="226692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9"/>
            <p:cNvSpPr/>
            <p:nvPr/>
          </p:nvSpPr>
          <p:spPr>
            <a:xfrm flipH="1" flipV="1">
              <a:off x="3693960" y="576000"/>
              <a:ext cx="658800" cy="223020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10"/>
            <p:cNvSpPr/>
            <p:nvPr/>
          </p:nvSpPr>
          <p:spPr>
            <a:xfrm>
              <a:off x="520560" y="4307040"/>
              <a:ext cx="892440" cy="45900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Purine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metabolis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11"/>
            <p:cNvSpPr/>
            <p:nvPr/>
          </p:nvSpPr>
          <p:spPr>
            <a:xfrm flipH="1">
              <a:off x="1426680" y="3209760"/>
              <a:ext cx="2413080" cy="120672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12"/>
            <p:cNvSpPr/>
            <p:nvPr/>
          </p:nvSpPr>
          <p:spPr>
            <a:xfrm flipH="1">
              <a:off x="1463400" y="2879640"/>
              <a:ext cx="3400200" cy="157320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13"/>
            <p:cNvSpPr/>
            <p:nvPr/>
          </p:nvSpPr>
          <p:spPr>
            <a:xfrm>
              <a:off x="6510240" y="320760"/>
              <a:ext cx="914400" cy="45900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RNA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metabolis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14"/>
            <p:cNvSpPr/>
            <p:nvPr/>
          </p:nvSpPr>
          <p:spPr>
            <a:xfrm flipV="1">
              <a:off x="5924520" y="795240"/>
              <a:ext cx="658800" cy="80496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16"/>
            <p:cNvSpPr/>
            <p:nvPr/>
          </p:nvSpPr>
          <p:spPr>
            <a:xfrm flipV="1">
              <a:off x="987480" y="430200"/>
              <a:ext cx="5522760" cy="157176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17"/>
            <p:cNvSpPr/>
            <p:nvPr/>
          </p:nvSpPr>
          <p:spPr>
            <a:xfrm>
              <a:off x="5054760" y="5770440"/>
              <a:ext cx="129780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Response to stres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18"/>
            <p:cNvSpPr/>
            <p:nvPr/>
          </p:nvSpPr>
          <p:spPr>
            <a:xfrm>
              <a:off x="4937040" y="4635360"/>
              <a:ext cx="330120" cy="109872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19"/>
            <p:cNvSpPr/>
            <p:nvPr/>
          </p:nvSpPr>
          <p:spPr>
            <a:xfrm>
              <a:off x="4095720" y="4599000"/>
              <a:ext cx="952560" cy="117144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20"/>
            <p:cNvSpPr/>
            <p:nvPr/>
          </p:nvSpPr>
          <p:spPr>
            <a:xfrm>
              <a:off x="4389480" y="38307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21"/>
            <p:cNvSpPr/>
            <p:nvPr/>
          </p:nvSpPr>
          <p:spPr>
            <a:xfrm>
              <a:off x="7534440" y="4197240"/>
              <a:ext cx="965160" cy="45900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cell wall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biosynthe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22"/>
            <p:cNvSpPr/>
            <p:nvPr/>
          </p:nvSpPr>
          <p:spPr>
            <a:xfrm>
              <a:off x="5778360" y="3063960"/>
              <a:ext cx="1756080" cy="1206360"/>
            </a:xfrm>
            <a:prstGeom prst="line">
              <a:avLst/>
            </a:prstGeom>
            <a:ln w="9360">
              <a:solidFill>
                <a:srgbClr val="80808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1" name="Text Box 24"/>
          <p:cNvSpPr/>
          <p:nvPr/>
        </p:nvSpPr>
        <p:spPr>
          <a:xfrm>
            <a:off x="165240" y="236520"/>
            <a:ext cx="63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EN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5-10T16:05:28Z</dcterms:created>
  <dc:creator>Shane Burgess</dc:creator>
  <dc:description/>
  <dc:language>en-US</dc:language>
  <cp:lastModifiedBy>Dr. Ahmed Hindawi</cp:lastModifiedBy>
  <dcterms:modified xsi:type="dcterms:W3CDTF">2008-04-22T11:11:41Z</dcterms:modified>
  <cp:revision>21</cp:revision>
  <dc:subject/>
  <dc:title>Slide 1</dc:title>
</cp:coreProperties>
</file>